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3CA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556" autoAdjust="0"/>
  </p:normalViewPr>
  <p:slideViewPr>
    <p:cSldViewPr>
      <p:cViewPr varScale="1">
        <p:scale>
          <a:sx n="84" d="100"/>
          <a:sy n="84" d="100"/>
        </p:scale>
        <p:origin x="1176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vf-i-humgen.lumcnet.prod.intern\humgen\lab-j\pietro\Monika\Mass%20Spec%20Monika\MS\iBAQ\ibaq%20top%20protein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vf-i-humgen.lumcnet.prod.intern\humgen\lab-j\pietro\Monika\Mass%20Spec%20Monika\MS\iBAQ\ibaq%20top%20protein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baq top proteins'!$C$17</c:f>
              <c:strCache>
                <c:ptCount val="1"/>
                <c:pt idx="0">
                  <c:v>MB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lumMod val="110000"/>
                    <a:satMod val="105000"/>
                    <a:tint val="67000"/>
                  </a:schemeClr>
                </a:gs>
                <a:gs pos="50000">
                  <a:schemeClr val="accent1">
                    <a:lumMod val="105000"/>
                    <a:satMod val="103000"/>
                    <a:tint val="73000"/>
                  </a:schemeClr>
                </a:gs>
                <a:gs pos="100000">
                  <a:schemeClr val="accent1"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accent1">
                  <a:shade val="95000"/>
                </a:schemeClr>
              </a:solidFill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ibaq top proteins'!$W$21,'ibaq top proteins'!$AD$21)</c:f>
                <c:numCache>
                  <c:formatCode>General</c:formatCode>
                  <c:ptCount val="2"/>
                  <c:pt idx="0">
                    <c:v>2594583.9276300389</c:v>
                  </c:pt>
                  <c:pt idx="1">
                    <c:v>45426457.9363447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('ibaq top proteins'!$X$16,'ibaq top proteins'!$AD$16)</c:f>
              <c:strCache>
                <c:ptCount val="2"/>
                <c:pt idx="0">
                  <c:v>GAPDH</c:v>
                </c:pt>
                <c:pt idx="1">
                  <c:v>ELAVL2/4</c:v>
                </c:pt>
              </c:strCache>
            </c:strRef>
          </c:cat>
          <c:val>
            <c:numRef>
              <c:f>('ibaq top proteins'!$X$17,'ibaq top proteins'!$AD$17)</c:f>
              <c:numCache>
                <c:formatCode>General</c:formatCode>
                <c:ptCount val="2"/>
                <c:pt idx="0">
                  <c:v>1665996.6666666667</c:v>
                </c:pt>
                <c:pt idx="1">
                  <c:v>1051270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76D-4F0E-B57F-AABC0C388436}"/>
            </c:ext>
          </c:extLst>
        </c:ser>
        <c:ser>
          <c:idx val="1"/>
          <c:order val="1"/>
          <c:tx>
            <c:strRef>
              <c:f>'ibaq top proteins'!$C$18</c:f>
              <c:strCache>
                <c:ptCount val="1"/>
                <c:pt idx="0">
                  <c:v>MT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lumMod val="110000"/>
                    <a:satMod val="105000"/>
                    <a:tint val="67000"/>
                  </a:schemeClr>
                </a:gs>
                <a:gs pos="50000">
                  <a:schemeClr val="accent2">
                    <a:lumMod val="105000"/>
                    <a:satMod val="103000"/>
                    <a:tint val="73000"/>
                  </a:schemeClr>
                </a:gs>
                <a:gs pos="100000">
                  <a:schemeClr val="accent2"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accent2">
                  <a:shade val="95000"/>
                </a:schemeClr>
              </a:solidFill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ibaq top proteins'!$X$22,'ibaq top proteins'!$AD$22)</c:f>
                <c:numCache>
                  <c:formatCode>General</c:formatCode>
                  <c:ptCount val="2"/>
                  <c:pt idx="0">
                    <c:v>207001522.00283492</c:v>
                  </c:pt>
                  <c:pt idx="1">
                    <c:v>128185425.766765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('ibaq top proteins'!$X$16,'ibaq top proteins'!$AD$16)</c:f>
              <c:strCache>
                <c:ptCount val="2"/>
                <c:pt idx="0">
                  <c:v>GAPDH</c:v>
                </c:pt>
                <c:pt idx="1">
                  <c:v>ELAVL2/4</c:v>
                </c:pt>
              </c:strCache>
            </c:strRef>
          </c:cat>
          <c:val>
            <c:numRef>
              <c:f>('ibaq top proteins'!$X$18,'ibaq top proteins'!$AD$18)</c:f>
              <c:numCache>
                <c:formatCode>General</c:formatCode>
                <c:ptCount val="2"/>
                <c:pt idx="0">
                  <c:v>327728401.66666669</c:v>
                </c:pt>
                <c:pt idx="1">
                  <c:v>383670083.33333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76D-4F0E-B57F-AABC0C3884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060272984"/>
        <c:axId val="1060273312"/>
      </c:barChart>
      <c:catAx>
        <c:axId val="10602729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60273312"/>
        <c:crosses val="autoZero"/>
        <c:auto val="1"/>
        <c:lblAlgn val="ctr"/>
        <c:lblOffset val="100"/>
        <c:noMultiLvlLbl val="0"/>
      </c:catAx>
      <c:valAx>
        <c:axId val="10602733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cap="none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nl-NL" sz="1000" cap="none" baseline="0"/>
                  <a:t>iBAQ intensity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cap="none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602729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799960642848222"/>
          <c:y val="3.3449348539817417E-2"/>
          <c:w val="0.84269493674664497"/>
          <c:h val="0.796268326507782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baq top proteins'!$C$17</c:f>
              <c:strCache>
                <c:ptCount val="1"/>
                <c:pt idx="0">
                  <c:v>MB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lumMod val="110000"/>
                    <a:satMod val="105000"/>
                    <a:tint val="67000"/>
                  </a:schemeClr>
                </a:gs>
                <a:gs pos="50000">
                  <a:schemeClr val="accent1">
                    <a:lumMod val="105000"/>
                    <a:satMod val="103000"/>
                    <a:tint val="73000"/>
                  </a:schemeClr>
                </a:gs>
                <a:gs pos="100000">
                  <a:schemeClr val="accent1"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accent1">
                  <a:shade val="95000"/>
                </a:schemeClr>
              </a:solidFill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ibaq top proteins'!$D$21:$W$21,'ibaq top proteins'!$Y$21:$AC$21,'ibaq top proteins'!$AE$21:$AI$21)</c:f>
                <c:numCache>
                  <c:formatCode>General</c:formatCode>
                  <c:ptCount val="30"/>
                  <c:pt idx="0">
                    <c:v>13996.500000000002</c:v>
                  </c:pt>
                  <c:pt idx="1">
                    <c:v>0</c:v>
                  </c:pt>
                  <c:pt idx="2">
                    <c:v>15069.666666666668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278483.33333333337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27647.971487273913</c:v>
                  </c:pt>
                  <c:pt idx="11">
                    <c:v>162789.06739713138</c:v>
                  </c:pt>
                  <c:pt idx="12">
                    <c:v>0</c:v>
                  </c:pt>
                  <c:pt idx="13">
                    <c:v>0</c:v>
                  </c:pt>
                  <c:pt idx="14">
                    <c:v>27981.666666666664</c:v>
                  </c:pt>
                  <c:pt idx="15">
                    <c:v>69240.000000000015</c:v>
                  </c:pt>
                  <c:pt idx="16">
                    <c:v>20613.333333333336</c:v>
                  </c:pt>
                  <c:pt idx="17">
                    <c:v>0</c:v>
                  </c:pt>
                  <c:pt idx="18">
                    <c:v>0</c:v>
                  </c:pt>
                  <c:pt idx="19">
                    <c:v>2594583.9276300389</c:v>
                  </c:pt>
                  <c:pt idx="20">
                    <c:v>114208.62089673152</c:v>
                  </c:pt>
                  <c:pt idx="21">
                    <c:v>57286.160364582538</c:v>
                  </c:pt>
                  <c:pt idx="22">
                    <c:v>306360.59516433318</c:v>
                  </c:pt>
                  <c:pt idx="23">
                    <c:v>65466.536870204</c:v>
                  </c:pt>
                  <c:pt idx="24">
                    <c:v>1076026.3995590573</c:v>
                  </c:pt>
                  <c:pt idx="25">
                    <c:v>0</c:v>
                  </c:pt>
                  <c:pt idx="26">
                    <c:v>11443551.791304911</c:v>
                  </c:pt>
                  <c:pt idx="27">
                    <c:v>3681767.1431543725</c:v>
                  </c:pt>
                  <c:pt idx="28">
                    <c:v>2195421.2132098177</c:v>
                  </c:pt>
                  <c:pt idx="29">
                    <c:v>1493672.81888582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('ibaq top proteins'!$D$16:$W$16,'ibaq top proteins'!$Y$16:$AC$16,'ibaq top proteins'!$AE$16:$AI$16)</c:f>
              <c:strCache>
                <c:ptCount val="30"/>
                <c:pt idx="0">
                  <c:v>NEB</c:v>
                </c:pt>
                <c:pt idx="1">
                  <c:v>MYH3</c:v>
                </c:pt>
                <c:pt idx="2">
                  <c:v>OBSCN</c:v>
                </c:pt>
                <c:pt idx="3">
                  <c:v>MYH8</c:v>
                </c:pt>
                <c:pt idx="4">
                  <c:v>DYSF</c:v>
                </c:pt>
                <c:pt idx="5">
                  <c:v>RYR1</c:v>
                </c:pt>
                <c:pt idx="6">
                  <c:v>WDR1</c:v>
                </c:pt>
                <c:pt idx="7">
                  <c:v>NACA</c:v>
                </c:pt>
                <c:pt idx="8">
                  <c:v>MYOF</c:v>
                </c:pt>
                <c:pt idx="9">
                  <c:v>MYO1C</c:v>
                </c:pt>
                <c:pt idx="10">
                  <c:v>MACF1</c:v>
                </c:pt>
                <c:pt idx="11">
                  <c:v>HSP90AB1</c:v>
                </c:pt>
                <c:pt idx="12">
                  <c:v>ATP2A2</c:v>
                </c:pt>
                <c:pt idx="13">
                  <c:v>SACS</c:v>
                </c:pt>
                <c:pt idx="14">
                  <c:v>COPA</c:v>
                </c:pt>
                <c:pt idx="15">
                  <c:v>RNH1</c:v>
                </c:pt>
                <c:pt idx="16">
                  <c:v>TUBB6</c:v>
                </c:pt>
                <c:pt idx="17">
                  <c:v>UBA1</c:v>
                </c:pt>
                <c:pt idx="18">
                  <c:v>TTN</c:v>
                </c:pt>
                <c:pt idx="19">
                  <c:v>DYNC1H1</c:v>
                </c:pt>
                <c:pt idx="20">
                  <c:v>FLNA</c:v>
                </c:pt>
                <c:pt idx="21">
                  <c:v>FLNC</c:v>
                </c:pt>
                <c:pt idx="22">
                  <c:v>MSN</c:v>
                </c:pt>
                <c:pt idx="23">
                  <c:v>MAP4</c:v>
                </c:pt>
                <c:pt idx="24">
                  <c:v>EIF3C_EIF3CL</c:v>
                </c:pt>
                <c:pt idx="25">
                  <c:v>FXR1</c:v>
                </c:pt>
                <c:pt idx="26">
                  <c:v>DDX21</c:v>
                </c:pt>
                <c:pt idx="27">
                  <c:v>RBM28</c:v>
                </c:pt>
                <c:pt idx="28">
                  <c:v>UTP15</c:v>
                </c:pt>
                <c:pt idx="29">
                  <c:v>MOV10</c:v>
                </c:pt>
              </c:strCache>
            </c:strRef>
          </c:cat>
          <c:val>
            <c:numRef>
              <c:f>('ibaq top proteins'!$D$17:$W$17,'ibaq top proteins'!$Y$17:$AC$17,'ibaq top proteins'!$AE$17:$AI$17)</c:f>
              <c:numCache>
                <c:formatCode>General</c:formatCode>
                <c:ptCount val="30"/>
                <c:pt idx="0">
                  <c:v>13996.5</c:v>
                </c:pt>
                <c:pt idx="1">
                  <c:v>0</c:v>
                </c:pt>
                <c:pt idx="2">
                  <c:v>15069.666666666666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78483.3333333333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91689.833333333328</c:v>
                </c:pt>
                <c:pt idx="11">
                  <c:v>175869.16666666666</c:v>
                </c:pt>
                <c:pt idx="12">
                  <c:v>0</c:v>
                </c:pt>
                <c:pt idx="13">
                  <c:v>0</c:v>
                </c:pt>
                <c:pt idx="14">
                  <c:v>27981.666666666668</c:v>
                </c:pt>
                <c:pt idx="15">
                  <c:v>69240</c:v>
                </c:pt>
                <c:pt idx="16">
                  <c:v>20613.333333333332</c:v>
                </c:pt>
                <c:pt idx="17">
                  <c:v>0</c:v>
                </c:pt>
                <c:pt idx="18">
                  <c:v>0</c:v>
                </c:pt>
                <c:pt idx="19">
                  <c:v>2613210.5</c:v>
                </c:pt>
                <c:pt idx="20">
                  <c:v>173716</c:v>
                </c:pt>
                <c:pt idx="21">
                  <c:v>109075.5</c:v>
                </c:pt>
                <c:pt idx="22">
                  <c:v>430449.66666666669</c:v>
                </c:pt>
                <c:pt idx="23">
                  <c:v>88970.333333333328</c:v>
                </c:pt>
                <c:pt idx="24">
                  <c:v>2898892.8333333335</c:v>
                </c:pt>
                <c:pt idx="25">
                  <c:v>0</c:v>
                </c:pt>
                <c:pt idx="26">
                  <c:v>32648816.666666668</c:v>
                </c:pt>
                <c:pt idx="27">
                  <c:v>8668723.333333334</c:v>
                </c:pt>
                <c:pt idx="28">
                  <c:v>4946655</c:v>
                </c:pt>
                <c:pt idx="29">
                  <c:v>45246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BDA-40A8-90A8-3DC5CCBA7568}"/>
            </c:ext>
          </c:extLst>
        </c:ser>
        <c:ser>
          <c:idx val="1"/>
          <c:order val="1"/>
          <c:tx>
            <c:strRef>
              <c:f>'ibaq top proteins'!$C$18</c:f>
              <c:strCache>
                <c:ptCount val="1"/>
                <c:pt idx="0">
                  <c:v>MT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lumMod val="110000"/>
                    <a:satMod val="105000"/>
                    <a:tint val="67000"/>
                  </a:schemeClr>
                </a:gs>
                <a:gs pos="50000">
                  <a:schemeClr val="accent2">
                    <a:lumMod val="105000"/>
                    <a:satMod val="103000"/>
                    <a:tint val="73000"/>
                  </a:schemeClr>
                </a:gs>
                <a:gs pos="100000">
                  <a:schemeClr val="accent2"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accent2">
                  <a:shade val="95000"/>
                </a:schemeClr>
              </a:solidFill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ibaq top proteins'!$D$22:$W$22,'ibaq top proteins'!$Y$22:$AC$22,'ibaq top proteins'!$AE$22:$AI$22)</c:f>
                <c:numCache>
                  <c:formatCode>General</c:formatCode>
                  <c:ptCount val="30"/>
                  <c:pt idx="0">
                    <c:v>10884959.293565493</c:v>
                  </c:pt>
                  <c:pt idx="1">
                    <c:v>89916540.426803783</c:v>
                  </c:pt>
                  <c:pt idx="2">
                    <c:v>5633838.3759074165</c:v>
                  </c:pt>
                  <c:pt idx="3">
                    <c:v>18177151.285517842</c:v>
                  </c:pt>
                  <c:pt idx="4">
                    <c:v>14755899.454877028</c:v>
                  </c:pt>
                  <c:pt idx="5">
                    <c:v>7176009.6106866151</c:v>
                  </c:pt>
                  <c:pt idx="6">
                    <c:v>40614800.015505403</c:v>
                  </c:pt>
                  <c:pt idx="7">
                    <c:v>4778853.9848380787</c:v>
                  </c:pt>
                  <c:pt idx="8">
                    <c:v>8426711.2103445753</c:v>
                  </c:pt>
                  <c:pt idx="9">
                    <c:v>16128249.631082106</c:v>
                  </c:pt>
                  <c:pt idx="10">
                    <c:v>1284005.9885125579</c:v>
                  </c:pt>
                  <c:pt idx="11">
                    <c:v>60396166.445310548</c:v>
                  </c:pt>
                  <c:pt idx="12">
                    <c:v>8328537.9915597597</c:v>
                  </c:pt>
                  <c:pt idx="13">
                    <c:v>952620.10461119516</c:v>
                  </c:pt>
                  <c:pt idx="14">
                    <c:v>3587606.9814738785</c:v>
                  </c:pt>
                  <c:pt idx="15">
                    <c:v>10750464.42051084</c:v>
                  </c:pt>
                  <c:pt idx="16">
                    <c:v>41715354.123395361</c:v>
                  </c:pt>
                  <c:pt idx="17">
                    <c:v>4395744.3000974664</c:v>
                  </c:pt>
                  <c:pt idx="18">
                    <c:v>142171.41218816736</c:v>
                  </c:pt>
                  <c:pt idx="19">
                    <c:v>26948015.387428194</c:v>
                  </c:pt>
                  <c:pt idx="20">
                    <c:v>15360892.689785976</c:v>
                  </c:pt>
                  <c:pt idx="21">
                    <c:v>32983599.879916728</c:v>
                  </c:pt>
                  <c:pt idx="22">
                    <c:v>26134997.109452896</c:v>
                  </c:pt>
                  <c:pt idx="23">
                    <c:v>508009.55711642653</c:v>
                  </c:pt>
                  <c:pt idx="24">
                    <c:v>4213191.4006903507</c:v>
                  </c:pt>
                  <c:pt idx="25">
                    <c:v>3294104.6693976442</c:v>
                  </c:pt>
                  <c:pt idx="26">
                    <c:v>2402235.2088502911</c:v>
                  </c:pt>
                  <c:pt idx="27">
                    <c:v>396470.45558205782</c:v>
                  </c:pt>
                  <c:pt idx="28">
                    <c:v>298368.86283498898</c:v>
                  </c:pt>
                  <c:pt idx="29">
                    <c:v>86113.5485018343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('ibaq top proteins'!$D$16:$W$16,'ibaq top proteins'!$Y$16:$AC$16,'ibaq top proteins'!$AE$16:$AI$16)</c:f>
              <c:strCache>
                <c:ptCount val="30"/>
                <c:pt idx="0">
                  <c:v>NEB</c:v>
                </c:pt>
                <c:pt idx="1">
                  <c:v>MYH3</c:v>
                </c:pt>
                <c:pt idx="2">
                  <c:v>OBSCN</c:v>
                </c:pt>
                <c:pt idx="3">
                  <c:v>MYH8</c:v>
                </c:pt>
                <c:pt idx="4">
                  <c:v>DYSF</c:v>
                </c:pt>
                <c:pt idx="5">
                  <c:v>RYR1</c:v>
                </c:pt>
                <c:pt idx="6">
                  <c:v>WDR1</c:v>
                </c:pt>
                <c:pt idx="7">
                  <c:v>NACA</c:v>
                </c:pt>
                <c:pt idx="8">
                  <c:v>MYOF</c:v>
                </c:pt>
                <c:pt idx="9">
                  <c:v>MYO1C</c:v>
                </c:pt>
                <c:pt idx="10">
                  <c:v>MACF1</c:v>
                </c:pt>
                <c:pt idx="11">
                  <c:v>HSP90AB1</c:v>
                </c:pt>
                <c:pt idx="12">
                  <c:v>ATP2A2</c:v>
                </c:pt>
                <c:pt idx="13">
                  <c:v>SACS</c:v>
                </c:pt>
                <c:pt idx="14">
                  <c:v>COPA</c:v>
                </c:pt>
                <c:pt idx="15">
                  <c:v>RNH1</c:v>
                </c:pt>
                <c:pt idx="16">
                  <c:v>TUBB6</c:v>
                </c:pt>
                <c:pt idx="17">
                  <c:v>UBA1</c:v>
                </c:pt>
                <c:pt idx="18">
                  <c:v>TTN</c:v>
                </c:pt>
                <c:pt idx="19">
                  <c:v>DYNC1H1</c:v>
                </c:pt>
                <c:pt idx="20">
                  <c:v>FLNA</c:v>
                </c:pt>
                <c:pt idx="21">
                  <c:v>FLNC</c:v>
                </c:pt>
                <c:pt idx="22">
                  <c:v>MSN</c:v>
                </c:pt>
                <c:pt idx="23">
                  <c:v>MAP4</c:v>
                </c:pt>
                <c:pt idx="24">
                  <c:v>EIF3C_EIF3CL</c:v>
                </c:pt>
                <c:pt idx="25">
                  <c:v>FXR1</c:v>
                </c:pt>
                <c:pt idx="26">
                  <c:v>DDX21</c:v>
                </c:pt>
                <c:pt idx="27">
                  <c:v>RBM28</c:v>
                </c:pt>
                <c:pt idx="28">
                  <c:v>UTP15</c:v>
                </c:pt>
                <c:pt idx="29">
                  <c:v>MOV10</c:v>
                </c:pt>
              </c:strCache>
            </c:strRef>
          </c:cat>
          <c:val>
            <c:numRef>
              <c:f>('ibaq top proteins'!$D$18:$W$18,'ibaq top proteins'!$Y$18:$AC$18,'ibaq top proteins'!$AE$18:$AI$18)</c:f>
              <c:numCache>
                <c:formatCode>General</c:formatCode>
                <c:ptCount val="30"/>
                <c:pt idx="0">
                  <c:v>13609413.333333334</c:v>
                </c:pt>
                <c:pt idx="1">
                  <c:v>106156043.66666667</c:v>
                </c:pt>
                <c:pt idx="2">
                  <c:v>6232270.666666667</c:v>
                </c:pt>
                <c:pt idx="3">
                  <c:v>20317251.666666668</c:v>
                </c:pt>
                <c:pt idx="4">
                  <c:v>17635060.333333332</c:v>
                </c:pt>
                <c:pt idx="5">
                  <c:v>8046300</c:v>
                </c:pt>
                <c:pt idx="6">
                  <c:v>61954696.666666664</c:v>
                </c:pt>
                <c:pt idx="7">
                  <c:v>5578178.333333333</c:v>
                </c:pt>
                <c:pt idx="8">
                  <c:v>8702044.5</c:v>
                </c:pt>
                <c:pt idx="9">
                  <c:v>24528550</c:v>
                </c:pt>
                <c:pt idx="10">
                  <c:v>1841018.3333333333</c:v>
                </c:pt>
                <c:pt idx="11">
                  <c:v>95663287.5</c:v>
                </c:pt>
                <c:pt idx="12">
                  <c:v>10047623.5</c:v>
                </c:pt>
                <c:pt idx="13">
                  <c:v>1077858.3333333333</c:v>
                </c:pt>
                <c:pt idx="14">
                  <c:v>4343589.666666667</c:v>
                </c:pt>
                <c:pt idx="15">
                  <c:v>16623681.666666666</c:v>
                </c:pt>
                <c:pt idx="16">
                  <c:v>65424183.333333336</c:v>
                </c:pt>
                <c:pt idx="17">
                  <c:v>6819061.166666667</c:v>
                </c:pt>
                <c:pt idx="18">
                  <c:v>208012.66666666666</c:v>
                </c:pt>
                <c:pt idx="19">
                  <c:v>36044880</c:v>
                </c:pt>
                <c:pt idx="20">
                  <c:v>21262588.5</c:v>
                </c:pt>
                <c:pt idx="21">
                  <c:v>49931369.5</c:v>
                </c:pt>
                <c:pt idx="22">
                  <c:v>29721933.333333332</c:v>
                </c:pt>
                <c:pt idx="23">
                  <c:v>872520.83333333337</c:v>
                </c:pt>
                <c:pt idx="24">
                  <c:v>12014006.666666666</c:v>
                </c:pt>
                <c:pt idx="25">
                  <c:v>6809960.833333333</c:v>
                </c:pt>
                <c:pt idx="26">
                  <c:v>7035700</c:v>
                </c:pt>
                <c:pt idx="27">
                  <c:v>952491.66666666663</c:v>
                </c:pt>
                <c:pt idx="28">
                  <c:v>416781.66666666669</c:v>
                </c:pt>
                <c:pt idx="29">
                  <c:v>275624.33333333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BDA-40A8-90A8-3DC5CCBA75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060272984"/>
        <c:axId val="1060273312"/>
      </c:barChart>
      <c:catAx>
        <c:axId val="10602729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60273312"/>
        <c:crosses val="autoZero"/>
        <c:auto val="1"/>
        <c:lblAlgn val="ctr"/>
        <c:lblOffset val="100"/>
        <c:noMultiLvlLbl val="0"/>
      </c:catAx>
      <c:valAx>
        <c:axId val="10602733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cap="none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nl-NL" sz="1000" cap="none" baseline="0"/>
                  <a:t>iBAQ intensity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cap="none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602729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CA6BBA-E1BE-4579-BF86-99327413F3E3}" type="datetimeFigureOut">
              <a:rPr lang="en-GB" smtClean="0"/>
              <a:t>22/08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D900E3-42B9-49DC-B81B-FC6B1116F2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26097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D900E3-42B9-49DC-B81B-FC6B1116F2E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18980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2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4837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2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8687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2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5969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2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2933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2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6747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2/08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099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2/08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4103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2/08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2466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2/08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2540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2/08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8677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2/08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5542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E5AFB6-9B44-4BC3-B3B2-7C6044D1C4BC}" type="datetimeFigureOut">
              <a:rPr lang="en-GB" smtClean="0"/>
              <a:t>22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398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6" name="Chart 25">
            <a:extLst>
              <a:ext uri="{FF2B5EF4-FFF2-40B4-BE49-F238E27FC236}">
                <a16:creationId xmlns:a16="http://schemas.microsoft.com/office/drawing/2014/main" id="{EBAE8DBA-1AEE-4E35-A267-03A9BEEBFB8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8287985"/>
              </p:ext>
            </p:extLst>
          </p:nvPr>
        </p:nvGraphicFramePr>
        <p:xfrm>
          <a:off x="0" y="1772816"/>
          <a:ext cx="1576076" cy="39633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7" name="Chart 26">
            <a:extLst>
              <a:ext uri="{FF2B5EF4-FFF2-40B4-BE49-F238E27FC236}">
                <a16:creationId xmlns:a16="http://schemas.microsoft.com/office/drawing/2014/main" id="{1FE47CB6-FD8A-4991-A73E-C9198B1971B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020221"/>
              </p:ext>
            </p:extLst>
          </p:nvPr>
        </p:nvGraphicFramePr>
        <p:xfrm>
          <a:off x="1723112" y="1700808"/>
          <a:ext cx="7236296" cy="41764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F0709202-8EB7-4732-8DF3-6585D1F5D73C}"/>
              </a:ext>
            </a:extLst>
          </p:cNvPr>
          <p:cNvSpPr txBox="1"/>
          <p:nvPr/>
        </p:nvSpPr>
        <p:spPr>
          <a:xfrm>
            <a:off x="29500" y="1340767"/>
            <a:ext cx="32395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	            B</a:t>
            </a:r>
            <a:endParaRPr lang="nl-N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8122509" y="1988840"/>
            <a:ext cx="1058988" cy="383232"/>
            <a:chOff x="755576" y="253244"/>
            <a:chExt cx="1058988" cy="383232"/>
          </a:xfrm>
        </p:grpSpPr>
        <p:sp>
          <p:nvSpPr>
            <p:cNvPr id="25" name="矩形 24"/>
            <p:cNvSpPr/>
            <p:nvPr/>
          </p:nvSpPr>
          <p:spPr>
            <a:xfrm>
              <a:off x="755576" y="332656"/>
              <a:ext cx="144016" cy="72008"/>
            </a:xfrm>
            <a:prstGeom prst="rect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929289" y="253244"/>
              <a:ext cx="7176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MT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943900" y="405644"/>
              <a:ext cx="8706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MB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>
              <a:off x="755576" y="485056"/>
              <a:ext cx="144016" cy="72008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3C64486F-1377-4C9B-8C85-D7F710F68262}"/>
              </a:ext>
            </a:extLst>
          </p:cNvPr>
          <p:cNvSpPr/>
          <p:nvPr/>
        </p:nvSpPr>
        <p:spPr>
          <a:xfrm rot="18787776">
            <a:off x="2605489" y="5266476"/>
            <a:ext cx="275195" cy="1475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AF4DDCDA-3C9A-48D8-9FAD-8BBDA2BDA682}"/>
              </a:ext>
            </a:extLst>
          </p:cNvPr>
          <p:cNvSpPr/>
          <p:nvPr/>
        </p:nvSpPr>
        <p:spPr>
          <a:xfrm rot="18787776">
            <a:off x="2751571" y="5293301"/>
            <a:ext cx="332987" cy="1475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0476CFAA-5BA8-4CAE-A297-5FEE40E467DE}"/>
              </a:ext>
            </a:extLst>
          </p:cNvPr>
          <p:cNvSpPr/>
          <p:nvPr/>
        </p:nvSpPr>
        <p:spPr>
          <a:xfrm rot="18787776">
            <a:off x="3157722" y="5282215"/>
            <a:ext cx="332987" cy="1475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87F674FB-47D9-4B0B-BCA3-790A6AAB3E33}"/>
              </a:ext>
            </a:extLst>
          </p:cNvPr>
          <p:cNvSpPr/>
          <p:nvPr/>
        </p:nvSpPr>
        <p:spPr>
          <a:xfrm rot="18787776">
            <a:off x="3371613" y="5284956"/>
            <a:ext cx="332987" cy="1475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CFB25574-5722-40E8-8377-6C18B4B359AA}"/>
              </a:ext>
            </a:extLst>
          </p:cNvPr>
          <p:cNvSpPr/>
          <p:nvPr/>
        </p:nvSpPr>
        <p:spPr>
          <a:xfrm rot="18787776">
            <a:off x="3972388" y="5282803"/>
            <a:ext cx="332987" cy="1475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F505BFF1-A78D-4F3A-9DF1-1586749BB072}"/>
              </a:ext>
            </a:extLst>
          </p:cNvPr>
          <p:cNvSpPr/>
          <p:nvPr/>
        </p:nvSpPr>
        <p:spPr>
          <a:xfrm rot="18787776">
            <a:off x="4177123" y="5293504"/>
            <a:ext cx="332987" cy="1475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1265874B-8A6E-4A94-ABF3-F46D4B1AE00A}"/>
              </a:ext>
            </a:extLst>
          </p:cNvPr>
          <p:cNvSpPr/>
          <p:nvPr/>
        </p:nvSpPr>
        <p:spPr>
          <a:xfrm rot="18787776">
            <a:off x="4581962" y="5366934"/>
            <a:ext cx="589909" cy="1475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0B728CB9-1768-4FF8-A3DF-0E526BB6972D}"/>
              </a:ext>
            </a:extLst>
          </p:cNvPr>
          <p:cNvSpPr/>
          <p:nvPr/>
        </p:nvSpPr>
        <p:spPr>
          <a:xfrm rot="18787776">
            <a:off x="4904488" y="5325880"/>
            <a:ext cx="443207" cy="1475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3D654B23-BBA3-49F4-91C6-6DB1A9C9A61F}"/>
              </a:ext>
            </a:extLst>
          </p:cNvPr>
          <p:cNvSpPr/>
          <p:nvPr/>
        </p:nvSpPr>
        <p:spPr>
          <a:xfrm rot="18787776">
            <a:off x="5774406" y="5306282"/>
            <a:ext cx="366286" cy="1475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6E800997-29DD-4D46-8099-98ED436B19E7}"/>
              </a:ext>
            </a:extLst>
          </p:cNvPr>
          <p:cNvSpPr/>
          <p:nvPr/>
        </p:nvSpPr>
        <p:spPr>
          <a:xfrm rot="18787776">
            <a:off x="6022479" y="5276662"/>
            <a:ext cx="332987" cy="1475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BF010898-21B9-44F9-A875-142DEBE6BFEA}"/>
              </a:ext>
            </a:extLst>
          </p:cNvPr>
          <p:cNvSpPr/>
          <p:nvPr/>
        </p:nvSpPr>
        <p:spPr>
          <a:xfrm rot="18787776">
            <a:off x="6271673" y="5266652"/>
            <a:ext cx="275195" cy="1475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F6FCA698-7C8E-48A3-B256-8620230F8335}"/>
              </a:ext>
            </a:extLst>
          </p:cNvPr>
          <p:cNvSpPr/>
          <p:nvPr/>
        </p:nvSpPr>
        <p:spPr>
          <a:xfrm rot="18787776">
            <a:off x="6834404" y="5277941"/>
            <a:ext cx="332987" cy="1475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B23323B4-AB8D-4BE1-A183-10931C6BE928}"/>
              </a:ext>
            </a:extLst>
          </p:cNvPr>
          <p:cNvSpPr/>
          <p:nvPr/>
        </p:nvSpPr>
        <p:spPr>
          <a:xfrm rot="18787776">
            <a:off x="7637781" y="5282215"/>
            <a:ext cx="332987" cy="1475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CA0D12CE-EC48-4DEA-B863-6F7629E4EDFC}"/>
              </a:ext>
            </a:extLst>
          </p:cNvPr>
          <p:cNvSpPr/>
          <p:nvPr/>
        </p:nvSpPr>
        <p:spPr>
          <a:xfrm rot="18787776">
            <a:off x="8204374" y="5311835"/>
            <a:ext cx="366286" cy="1475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18D5662F-67DE-40BB-B49B-58A5A16BCF30}"/>
              </a:ext>
            </a:extLst>
          </p:cNvPr>
          <p:cNvSpPr/>
          <p:nvPr/>
        </p:nvSpPr>
        <p:spPr>
          <a:xfrm rot="18787776">
            <a:off x="8394905" y="5304793"/>
            <a:ext cx="402915" cy="1475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36355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82</TotalTime>
  <Words>8</Words>
  <Application>Microsoft Office PowerPoint</Application>
  <PresentationFormat>全屏显示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Theme</vt:lpstr>
      <vt:lpstr>PowerPoint 演示文稿</vt:lpstr>
    </vt:vector>
  </TitlesOfParts>
  <Company>LU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pitali, P. (HG)</dc:creator>
  <cp:lastModifiedBy>SPEED</cp:lastModifiedBy>
  <cp:revision>257</cp:revision>
  <dcterms:created xsi:type="dcterms:W3CDTF">2018-04-30T14:21:34Z</dcterms:created>
  <dcterms:modified xsi:type="dcterms:W3CDTF">2020-08-23T02:32:38Z</dcterms:modified>
</cp:coreProperties>
</file>